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1" r:id="rId2"/>
  </p:sldIdLst>
  <p:sldSz cx="11699875" cy="14471650"/>
  <p:notesSz cx="6858000" cy="9144000"/>
  <p:defaultTextStyle>
    <a:defPPr>
      <a:defRPr lang="ja-JP"/>
    </a:defPPr>
    <a:lvl1pPr marL="0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1pPr>
    <a:lvl2pPr marL="747695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2pPr>
    <a:lvl3pPr marL="1495390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3pPr>
    <a:lvl4pPr marL="2243085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4pPr>
    <a:lvl5pPr marL="2990781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5pPr>
    <a:lvl6pPr marL="3738476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6pPr>
    <a:lvl7pPr marL="4486171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7pPr>
    <a:lvl8pPr marL="5233866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8pPr>
    <a:lvl9pPr marL="5981561" algn="l" defTabSz="1495390" rtl="0" eaLnBrk="1" latinLnBrk="0" hangingPunct="1">
      <a:defRPr kumimoji="1" sz="294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58" userDrawn="1">
          <p15:clr>
            <a:srgbClr val="A4A3A4"/>
          </p15:clr>
        </p15:guide>
        <p15:guide id="2" pos="36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34" autoAdjust="0"/>
    <p:restoredTop sz="94087" autoAdjust="0"/>
  </p:normalViewPr>
  <p:slideViewPr>
    <p:cSldViewPr snapToGrid="0">
      <p:cViewPr varScale="1">
        <p:scale>
          <a:sx n="32" d="100"/>
          <a:sy n="32" d="100"/>
        </p:scale>
        <p:origin x="1968" y="44"/>
      </p:cViewPr>
      <p:guideLst>
        <p:guide orient="horz" pos="4558"/>
        <p:guide pos="36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AD3E61-EC32-483D-9DDF-57D11B031888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82813" y="1143000"/>
            <a:ext cx="24923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4B1162-AEBC-4D44-87BC-B2984C296D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4129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1pPr>
    <a:lvl2pPr marL="747695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2pPr>
    <a:lvl3pPr marL="1495390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3pPr>
    <a:lvl4pPr marL="2243085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4pPr>
    <a:lvl5pPr marL="2990781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5pPr>
    <a:lvl6pPr marL="3738476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6pPr>
    <a:lvl7pPr marL="4486171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7pPr>
    <a:lvl8pPr marL="5233866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8pPr>
    <a:lvl9pPr marL="5981561" algn="l" defTabSz="1495390" rtl="0" eaLnBrk="1" latinLnBrk="0" hangingPunct="1">
      <a:defRPr kumimoji="1" sz="19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77491" y="2368394"/>
            <a:ext cx="9944894" cy="5038278"/>
          </a:xfrm>
        </p:spPr>
        <p:txBody>
          <a:bodyPr anchor="b"/>
          <a:lstStyle>
            <a:lvl1pPr algn="ctr">
              <a:defRPr sz="767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62485" y="7600967"/>
            <a:ext cx="8774906" cy="3493964"/>
          </a:xfrm>
        </p:spPr>
        <p:txBody>
          <a:bodyPr/>
          <a:lstStyle>
            <a:lvl1pPr marL="0" indent="0" algn="ctr">
              <a:buNone/>
              <a:defRPr sz="3071"/>
            </a:lvl1pPr>
            <a:lvl2pPr marL="584987" indent="0" algn="ctr">
              <a:buNone/>
              <a:defRPr sz="2559"/>
            </a:lvl2pPr>
            <a:lvl3pPr marL="1169975" indent="0" algn="ctr">
              <a:buNone/>
              <a:defRPr sz="2303"/>
            </a:lvl3pPr>
            <a:lvl4pPr marL="1754962" indent="0" algn="ctr">
              <a:buNone/>
              <a:defRPr sz="2047"/>
            </a:lvl4pPr>
            <a:lvl5pPr marL="2339950" indent="0" algn="ctr">
              <a:buNone/>
              <a:defRPr sz="2047"/>
            </a:lvl5pPr>
            <a:lvl6pPr marL="2924937" indent="0" algn="ctr">
              <a:buNone/>
              <a:defRPr sz="2047"/>
            </a:lvl6pPr>
            <a:lvl7pPr marL="3509924" indent="0" algn="ctr">
              <a:buNone/>
              <a:defRPr sz="2047"/>
            </a:lvl7pPr>
            <a:lvl8pPr marL="4094912" indent="0" algn="ctr">
              <a:buNone/>
              <a:defRPr sz="2047"/>
            </a:lvl8pPr>
            <a:lvl9pPr marL="4679899" indent="0" algn="ctr">
              <a:buNone/>
              <a:defRPr sz="2047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6367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3582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372723" y="770482"/>
            <a:ext cx="2522786" cy="12264054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04367" y="770482"/>
            <a:ext cx="7422108" cy="12264054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162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319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8273" y="3607867"/>
            <a:ext cx="10091142" cy="6019803"/>
          </a:xfrm>
        </p:spPr>
        <p:txBody>
          <a:bodyPr anchor="b"/>
          <a:lstStyle>
            <a:lvl1pPr>
              <a:defRPr sz="767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8273" y="9684620"/>
            <a:ext cx="10091142" cy="3165672"/>
          </a:xfrm>
        </p:spPr>
        <p:txBody>
          <a:bodyPr/>
          <a:lstStyle>
            <a:lvl1pPr marL="0" indent="0">
              <a:buNone/>
              <a:defRPr sz="3071">
                <a:solidFill>
                  <a:schemeClr val="tx1"/>
                </a:solidFill>
              </a:defRPr>
            </a:lvl1pPr>
            <a:lvl2pPr marL="584987" indent="0">
              <a:buNone/>
              <a:defRPr sz="2559">
                <a:solidFill>
                  <a:schemeClr val="tx1">
                    <a:tint val="75000"/>
                  </a:schemeClr>
                </a:solidFill>
              </a:defRPr>
            </a:lvl2pPr>
            <a:lvl3pPr marL="1169975" indent="0">
              <a:buNone/>
              <a:defRPr sz="2303">
                <a:solidFill>
                  <a:schemeClr val="tx1">
                    <a:tint val="75000"/>
                  </a:schemeClr>
                </a:solidFill>
              </a:defRPr>
            </a:lvl3pPr>
            <a:lvl4pPr marL="1754962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4pPr>
            <a:lvl5pPr marL="2339950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5pPr>
            <a:lvl6pPr marL="2924937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6pPr>
            <a:lvl7pPr marL="3509924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7pPr>
            <a:lvl8pPr marL="4094912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8pPr>
            <a:lvl9pPr marL="4679899" indent="0">
              <a:buNone/>
              <a:defRPr sz="204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044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04366" y="3852407"/>
            <a:ext cx="4972447" cy="918212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23062" y="3852407"/>
            <a:ext cx="4972447" cy="918212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69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5890" y="770485"/>
            <a:ext cx="10091142" cy="279718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05891" y="3547565"/>
            <a:ext cx="4949595" cy="1738607"/>
          </a:xfrm>
        </p:spPr>
        <p:txBody>
          <a:bodyPr anchor="b"/>
          <a:lstStyle>
            <a:lvl1pPr marL="0" indent="0">
              <a:buNone/>
              <a:defRPr sz="3071" b="1"/>
            </a:lvl1pPr>
            <a:lvl2pPr marL="584987" indent="0">
              <a:buNone/>
              <a:defRPr sz="2559" b="1"/>
            </a:lvl2pPr>
            <a:lvl3pPr marL="1169975" indent="0">
              <a:buNone/>
              <a:defRPr sz="2303" b="1"/>
            </a:lvl3pPr>
            <a:lvl4pPr marL="1754962" indent="0">
              <a:buNone/>
              <a:defRPr sz="2047" b="1"/>
            </a:lvl4pPr>
            <a:lvl5pPr marL="2339950" indent="0">
              <a:buNone/>
              <a:defRPr sz="2047" b="1"/>
            </a:lvl5pPr>
            <a:lvl6pPr marL="2924937" indent="0">
              <a:buNone/>
              <a:defRPr sz="2047" b="1"/>
            </a:lvl6pPr>
            <a:lvl7pPr marL="3509924" indent="0">
              <a:buNone/>
              <a:defRPr sz="2047" b="1"/>
            </a:lvl7pPr>
            <a:lvl8pPr marL="4094912" indent="0">
              <a:buNone/>
              <a:defRPr sz="2047" b="1"/>
            </a:lvl8pPr>
            <a:lvl9pPr marL="4679899" indent="0">
              <a:buNone/>
              <a:defRPr sz="2047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05891" y="5286172"/>
            <a:ext cx="4949595" cy="777516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923062" y="3547565"/>
            <a:ext cx="4973971" cy="1738607"/>
          </a:xfrm>
        </p:spPr>
        <p:txBody>
          <a:bodyPr anchor="b"/>
          <a:lstStyle>
            <a:lvl1pPr marL="0" indent="0">
              <a:buNone/>
              <a:defRPr sz="3071" b="1"/>
            </a:lvl1pPr>
            <a:lvl2pPr marL="584987" indent="0">
              <a:buNone/>
              <a:defRPr sz="2559" b="1"/>
            </a:lvl2pPr>
            <a:lvl3pPr marL="1169975" indent="0">
              <a:buNone/>
              <a:defRPr sz="2303" b="1"/>
            </a:lvl3pPr>
            <a:lvl4pPr marL="1754962" indent="0">
              <a:buNone/>
              <a:defRPr sz="2047" b="1"/>
            </a:lvl4pPr>
            <a:lvl5pPr marL="2339950" indent="0">
              <a:buNone/>
              <a:defRPr sz="2047" b="1"/>
            </a:lvl5pPr>
            <a:lvl6pPr marL="2924937" indent="0">
              <a:buNone/>
              <a:defRPr sz="2047" b="1"/>
            </a:lvl6pPr>
            <a:lvl7pPr marL="3509924" indent="0">
              <a:buNone/>
              <a:defRPr sz="2047" b="1"/>
            </a:lvl7pPr>
            <a:lvl8pPr marL="4094912" indent="0">
              <a:buNone/>
              <a:defRPr sz="2047" b="1"/>
            </a:lvl8pPr>
            <a:lvl9pPr marL="4679899" indent="0">
              <a:buNone/>
              <a:defRPr sz="2047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923062" y="5286172"/>
            <a:ext cx="4973971" cy="777516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130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3782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019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5890" y="964777"/>
            <a:ext cx="3773514" cy="3376718"/>
          </a:xfrm>
        </p:spPr>
        <p:txBody>
          <a:bodyPr anchor="b"/>
          <a:lstStyle>
            <a:lvl1pPr>
              <a:defRPr sz="409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73971" y="2083653"/>
            <a:ext cx="5923062" cy="10284251"/>
          </a:xfrm>
        </p:spPr>
        <p:txBody>
          <a:bodyPr/>
          <a:lstStyle>
            <a:lvl1pPr>
              <a:defRPr sz="4094"/>
            </a:lvl1pPr>
            <a:lvl2pPr>
              <a:defRPr sz="3583"/>
            </a:lvl2pPr>
            <a:lvl3pPr>
              <a:defRPr sz="3071"/>
            </a:lvl3pPr>
            <a:lvl4pPr>
              <a:defRPr sz="2559"/>
            </a:lvl4pPr>
            <a:lvl5pPr>
              <a:defRPr sz="2559"/>
            </a:lvl5pPr>
            <a:lvl6pPr>
              <a:defRPr sz="2559"/>
            </a:lvl6pPr>
            <a:lvl7pPr>
              <a:defRPr sz="2559"/>
            </a:lvl7pPr>
            <a:lvl8pPr>
              <a:defRPr sz="2559"/>
            </a:lvl8pPr>
            <a:lvl9pPr>
              <a:defRPr sz="2559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05890" y="4341495"/>
            <a:ext cx="3773514" cy="8043157"/>
          </a:xfrm>
        </p:spPr>
        <p:txBody>
          <a:bodyPr/>
          <a:lstStyle>
            <a:lvl1pPr marL="0" indent="0">
              <a:buNone/>
              <a:defRPr sz="2047"/>
            </a:lvl1pPr>
            <a:lvl2pPr marL="584987" indent="0">
              <a:buNone/>
              <a:defRPr sz="1791"/>
            </a:lvl2pPr>
            <a:lvl3pPr marL="1169975" indent="0">
              <a:buNone/>
              <a:defRPr sz="1535"/>
            </a:lvl3pPr>
            <a:lvl4pPr marL="1754962" indent="0">
              <a:buNone/>
              <a:defRPr sz="1280"/>
            </a:lvl4pPr>
            <a:lvl5pPr marL="2339950" indent="0">
              <a:buNone/>
              <a:defRPr sz="1280"/>
            </a:lvl5pPr>
            <a:lvl6pPr marL="2924937" indent="0">
              <a:buNone/>
              <a:defRPr sz="1280"/>
            </a:lvl6pPr>
            <a:lvl7pPr marL="3509924" indent="0">
              <a:buNone/>
              <a:defRPr sz="1280"/>
            </a:lvl7pPr>
            <a:lvl8pPr marL="4094912" indent="0">
              <a:buNone/>
              <a:defRPr sz="1280"/>
            </a:lvl8pPr>
            <a:lvl9pPr marL="4679899" indent="0">
              <a:buNone/>
              <a:defRPr sz="128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682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5890" y="964777"/>
            <a:ext cx="3773514" cy="3376718"/>
          </a:xfrm>
        </p:spPr>
        <p:txBody>
          <a:bodyPr anchor="b"/>
          <a:lstStyle>
            <a:lvl1pPr>
              <a:defRPr sz="409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973971" y="2083653"/>
            <a:ext cx="5923062" cy="10284251"/>
          </a:xfrm>
        </p:spPr>
        <p:txBody>
          <a:bodyPr anchor="t"/>
          <a:lstStyle>
            <a:lvl1pPr marL="0" indent="0">
              <a:buNone/>
              <a:defRPr sz="4094"/>
            </a:lvl1pPr>
            <a:lvl2pPr marL="584987" indent="0">
              <a:buNone/>
              <a:defRPr sz="3583"/>
            </a:lvl2pPr>
            <a:lvl3pPr marL="1169975" indent="0">
              <a:buNone/>
              <a:defRPr sz="3071"/>
            </a:lvl3pPr>
            <a:lvl4pPr marL="1754962" indent="0">
              <a:buNone/>
              <a:defRPr sz="2559"/>
            </a:lvl4pPr>
            <a:lvl5pPr marL="2339950" indent="0">
              <a:buNone/>
              <a:defRPr sz="2559"/>
            </a:lvl5pPr>
            <a:lvl6pPr marL="2924937" indent="0">
              <a:buNone/>
              <a:defRPr sz="2559"/>
            </a:lvl6pPr>
            <a:lvl7pPr marL="3509924" indent="0">
              <a:buNone/>
              <a:defRPr sz="2559"/>
            </a:lvl7pPr>
            <a:lvl8pPr marL="4094912" indent="0">
              <a:buNone/>
              <a:defRPr sz="2559"/>
            </a:lvl8pPr>
            <a:lvl9pPr marL="4679899" indent="0">
              <a:buNone/>
              <a:defRPr sz="2559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05890" y="4341495"/>
            <a:ext cx="3773514" cy="8043157"/>
          </a:xfrm>
        </p:spPr>
        <p:txBody>
          <a:bodyPr/>
          <a:lstStyle>
            <a:lvl1pPr marL="0" indent="0">
              <a:buNone/>
              <a:defRPr sz="2047"/>
            </a:lvl1pPr>
            <a:lvl2pPr marL="584987" indent="0">
              <a:buNone/>
              <a:defRPr sz="1791"/>
            </a:lvl2pPr>
            <a:lvl3pPr marL="1169975" indent="0">
              <a:buNone/>
              <a:defRPr sz="1535"/>
            </a:lvl3pPr>
            <a:lvl4pPr marL="1754962" indent="0">
              <a:buNone/>
              <a:defRPr sz="1280"/>
            </a:lvl4pPr>
            <a:lvl5pPr marL="2339950" indent="0">
              <a:buNone/>
              <a:defRPr sz="1280"/>
            </a:lvl5pPr>
            <a:lvl6pPr marL="2924937" indent="0">
              <a:buNone/>
              <a:defRPr sz="1280"/>
            </a:lvl6pPr>
            <a:lvl7pPr marL="3509924" indent="0">
              <a:buNone/>
              <a:defRPr sz="1280"/>
            </a:lvl7pPr>
            <a:lvl8pPr marL="4094912" indent="0">
              <a:buNone/>
              <a:defRPr sz="1280"/>
            </a:lvl8pPr>
            <a:lvl9pPr marL="4679899" indent="0">
              <a:buNone/>
              <a:defRPr sz="128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900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04367" y="770485"/>
            <a:ext cx="10091142" cy="27971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04367" y="3852407"/>
            <a:ext cx="10091142" cy="91821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04366" y="13413079"/>
            <a:ext cx="2632472" cy="770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BB0E7-E129-40C4-85C7-B72E3E7E807F}" type="datetimeFigureOut">
              <a:rPr kumimoji="1" lang="ja-JP" altLang="en-US" smtClean="0"/>
              <a:t>2019/5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75584" y="13413079"/>
            <a:ext cx="3948708" cy="770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263037" y="13413079"/>
            <a:ext cx="2632472" cy="770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598C8A-9444-471C-BF93-A931963191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994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169975" rtl="0" eaLnBrk="1" latinLnBrk="0" hangingPunct="1">
        <a:lnSpc>
          <a:spcPct val="90000"/>
        </a:lnSpc>
        <a:spcBef>
          <a:spcPct val="0"/>
        </a:spcBef>
        <a:buNone/>
        <a:defRPr kumimoji="1" sz="5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2494" indent="-292494" algn="l" defTabSz="1169975" rtl="0" eaLnBrk="1" latinLnBrk="0" hangingPunct="1">
        <a:lnSpc>
          <a:spcPct val="90000"/>
        </a:lnSpc>
        <a:spcBef>
          <a:spcPts val="1280"/>
        </a:spcBef>
        <a:buFont typeface="Arial" panose="020B0604020202020204" pitchFamily="34" charset="0"/>
        <a:buChar char="•"/>
        <a:defRPr kumimoji="1" sz="3583" kern="1200">
          <a:solidFill>
            <a:schemeClr val="tx1"/>
          </a:solidFill>
          <a:latin typeface="+mn-lt"/>
          <a:ea typeface="+mn-ea"/>
          <a:cs typeface="+mn-cs"/>
        </a:defRPr>
      </a:lvl1pPr>
      <a:lvl2pPr marL="877481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3071" kern="1200">
          <a:solidFill>
            <a:schemeClr val="tx1"/>
          </a:solidFill>
          <a:latin typeface="+mn-lt"/>
          <a:ea typeface="+mn-ea"/>
          <a:cs typeface="+mn-cs"/>
        </a:defRPr>
      </a:lvl2pPr>
      <a:lvl3pPr marL="1462469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559" kern="1200">
          <a:solidFill>
            <a:schemeClr val="tx1"/>
          </a:solidFill>
          <a:latin typeface="+mn-lt"/>
          <a:ea typeface="+mn-ea"/>
          <a:cs typeface="+mn-cs"/>
        </a:defRPr>
      </a:lvl3pPr>
      <a:lvl4pPr marL="2047456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4pPr>
      <a:lvl5pPr marL="2632443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5pPr>
      <a:lvl6pPr marL="3217431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6pPr>
      <a:lvl7pPr marL="3802418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7pPr>
      <a:lvl8pPr marL="4387406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8pPr>
      <a:lvl9pPr marL="4972393" indent="-292494" algn="l" defTabSz="1169975" rtl="0" eaLnBrk="1" latinLnBrk="0" hangingPunct="1">
        <a:lnSpc>
          <a:spcPct val="90000"/>
        </a:lnSpc>
        <a:spcBef>
          <a:spcPts val="640"/>
        </a:spcBef>
        <a:buFont typeface="Arial" panose="020B0604020202020204" pitchFamily="34" charset="0"/>
        <a:buChar char="•"/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1pPr>
      <a:lvl2pPr marL="584987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2pPr>
      <a:lvl3pPr marL="1169975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3pPr>
      <a:lvl4pPr marL="1754962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4pPr>
      <a:lvl5pPr marL="2339950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5pPr>
      <a:lvl6pPr marL="2924937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6pPr>
      <a:lvl7pPr marL="3509924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7pPr>
      <a:lvl8pPr marL="4094912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8pPr>
      <a:lvl9pPr marL="4679899" algn="l" defTabSz="1169975" rtl="0" eaLnBrk="1" latinLnBrk="0" hangingPunct="1">
        <a:defRPr kumimoji="1" sz="230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gi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グループ化 107"/>
          <p:cNvGrpSpPr/>
          <p:nvPr/>
        </p:nvGrpSpPr>
        <p:grpSpPr>
          <a:xfrm>
            <a:off x="192872" y="709570"/>
            <a:ext cx="11260108" cy="12529419"/>
            <a:chOff x="192872" y="709570"/>
            <a:chExt cx="11260108" cy="12529419"/>
          </a:xfrm>
        </p:grpSpPr>
        <p:sp>
          <p:nvSpPr>
            <p:cNvPr id="2" name="テキスト ボックス 1"/>
            <p:cNvSpPr txBox="1"/>
            <p:nvPr/>
          </p:nvSpPr>
          <p:spPr>
            <a:xfrm>
              <a:off x="331207" y="762919"/>
              <a:ext cx="26844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800" b="1" dirty="0"/>
                <a:t>a</a:t>
              </a:r>
              <a:endParaRPr lang="ja-JP" altLang="en-US" sz="2800" b="1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327092" y="9822669"/>
              <a:ext cx="11125888" cy="34163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1</a:t>
              </a: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Establishment of patient-derived xenografts. (a) </a:t>
              </a:r>
              <a:r>
                <a:rPr lang="en-US" altLang="ja-JP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G </a:t>
              </a: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e were prepared between 6 and 12 weeks of age. Tumor tissues for transplantation were obtained from patients with pancreatic cancer. Fresh tumor tissues were divided into small pieces and implanted into </a:t>
              </a:r>
              <a:r>
                <a:rPr lang="en-US" altLang="ja-JP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G </a:t>
              </a: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e in the dorsal subcutaneous area of the upper part of the back. (b) After the engrafted mass expanded well, the xenograft tumor was </a:t>
              </a:r>
              <a:r>
                <a:rPr lang="en-US" altLang="ja-JP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-transplanted </a:t>
              </a: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expansion in another </a:t>
              </a:r>
              <a:r>
                <a:rPr lang="en-US" altLang="ja-JP" sz="2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G </a:t>
              </a: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use using the same procedure. We repeated this procedure and passaged the PDXs. (c) Tumor growth curves for one representative pancreatic PDX line. The tumor volume reached around 1000 mm</a:t>
              </a:r>
              <a:r>
                <a:rPr lang="en-US" altLang="ja-JP" sz="2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the mouse was sacrificed, and the tumor was isolated and transplanted into the next mouse.</a:t>
              </a:r>
              <a:endParaRPr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9" name="グループ化 58"/>
            <p:cNvGrpSpPr/>
            <p:nvPr/>
          </p:nvGrpSpPr>
          <p:grpSpPr>
            <a:xfrm>
              <a:off x="192872" y="971180"/>
              <a:ext cx="11260108" cy="8658091"/>
              <a:chOff x="494785" y="-1758438"/>
              <a:chExt cx="11260108" cy="8658091"/>
            </a:xfrm>
          </p:grpSpPr>
          <p:grpSp>
            <p:nvGrpSpPr>
              <p:cNvPr id="60" name="グループ化 59"/>
              <p:cNvGrpSpPr/>
              <p:nvPr/>
            </p:nvGrpSpPr>
            <p:grpSpPr>
              <a:xfrm>
                <a:off x="863178" y="4112933"/>
                <a:ext cx="10505900" cy="2786720"/>
                <a:chOff x="863178" y="4112933"/>
                <a:chExt cx="10505900" cy="2786720"/>
              </a:xfrm>
            </p:grpSpPr>
            <p:sp>
              <p:nvSpPr>
                <p:cNvPr id="100" name="テキスト ボックス 99"/>
                <p:cNvSpPr txBox="1"/>
                <p:nvPr/>
              </p:nvSpPr>
              <p:spPr>
                <a:xfrm>
                  <a:off x="2453789" y="4119090"/>
                  <a:ext cx="539698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2400" b="1" dirty="0"/>
                    <a:t>G1</a:t>
                  </a:r>
                  <a:endParaRPr lang="ja-JP" altLang="en-US" sz="2400" b="1" dirty="0"/>
                </a:p>
              </p:txBody>
            </p:sp>
            <p:sp>
              <p:nvSpPr>
                <p:cNvPr id="101" name="テキスト ボックス 100"/>
                <p:cNvSpPr txBox="1"/>
                <p:nvPr/>
              </p:nvSpPr>
              <p:spPr>
                <a:xfrm>
                  <a:off x="6096626" y="4112934"/>
                  <a:ext cx="539698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2400" b="1" dirty="0"/>
                    <a:t>G2</a:t>
                  </a:r>
                  <a:endParaRPr lang="ja-JP" altLang="en-US" sz="2400" b="1" dirty="0"/>
                </a:p>
              </p:txBody>
            </p:sp>
            <p:sp>
              <p:nvSpPr>
                <p:cNvPr id="102" name="テキスト ボックス 101"/>
                <p:cNvSpPr txBox="1"/>
                <p:nvPr/>
              </p:nvSpPr>
              <p:spPr>
                <a:xfrm>
                  <a:off x="9562088" y="4112933"/>
                  <a:ext cx="670726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2400" b="1" dirty="0"/>
                    <a:t>G3</a:t>
                  </a:r>
                  <a:endParaRPr lang="ja-JP" altLang="en-US" sz="2400" b="1" dirty="0"/>
                </a:p>
              </p:txBody>
            </p:sp>
            <p:pic>
              <p:nvPicPr>
                <p:cNvPr id="103" name="図 102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8044279" y="4524796"/>
                  <a:ext cx="3324799" cy="2374857"/>
                </a:xfrm>
                <a:prstGeom prst="rect">
                  <a:avLst/>
                </a:prstGeom>
              </p:spPr>
            </p:pic>
            <p:pic>
              <p:nvPicPr>
                <p:cNvPr id="104" name="図 103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483459" y="4524795"/>
                  <a:ext cx="3324799" cy="2374857"/>
                </a:xfrm>
                <a:prstGeom prst="rect">
                  <a:avLst/>
                </a:prstGeom>
              </p:spPr>
            </p:pic>
            <p:pic>
              <p:nvPicPr>
                <p:cNvPr id="105" name="図 104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863178" y="4524794"/>
                  <a:ext cx="3336978" cy="2374857"/>
                </a:xfrm>
                <a:prstGeom prst="rect">
                  <a:avLst/>
                </a:prstGeom>
              </p:spPr>
            </p:pic>
          </p:grpSp>
          <p:grpSp>
            <p:nvGrpSpPr>
              <p:cNvPr id="61" name="グループ化 60"/>
              <p:cNvGrpSpPr/>
              <p:nvPr/>
            </p:nvGrpSpPr>
            <p:grpSpPr>
              <a:xfrm>
                <a:off x="5821418" y="-1758438"/>
                <a:ext cx="5933475" cy="5353039"/>
                <a:chOff x="5821418" y="-1758438"/>
                <a:chExt cx="5933475" cy="5353039"/>
              </a:xfrm>
            </p:grpSpPr>
            <p:sp>
              <p:nvSpPr>
                <p:cNvPr id="74" name="テキスト ボックス 73"/>
                <p:cNvSpPr txBox="1"/>
                <p:nvPr/>
              </p:nvSpPr>
              <p:spPr>
                <a:xfrm>
                  <a:off x="6291291" y="-137029"/>
                  <a:ext cx="479618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000" b="1" dirty="0" smtClean="0"/>
                    <a:t>G1</a:t>
                  </a:r>
                  <a:endParaRPr kumimoji="1" lang="ja-JP" altLang="en-US" sz="2000" b="1" dirty="0"/>
                </a:p>
              </p:txBody>
            </p:sp>
            <p:sp>
              <p:nvSpPr>
                <p:cNvPr id="75" name="テキスト ボックス 74"/>
                <p:cNvSpPr txBox="1"/>
                <p:nvPr/>
              </p:nvSpPr>
              <p:spPr>
                <a:xfrm>
                  <a:off x="6291291" y="1363505"/>
                  <a:ext cx="476463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000" b="1" dirty="0" smtClean="0"/>
                    <a:t>G2</a:t>
                  </a:r>
                  <a:endParaRPr kumimoji="1" lang="ja-JP" altLang="en-US" sz="2000" b="1" dirty="0"/>
                </a:p>
              </p:txBody>
            </p:sp>
            <p:sp>
              <p:nvSpPr>
                <p:cNvPr id="76" name="テキスト ボックス 75"/>
                <p:cNvSpPr txBox="1"/>
                <p:nvPr/>
              </p:nvSpPr>
              <p:spPr>
                <a:xfrm>
                  <a:off x="6291291" y="2857659"/>
                  <a:ext cx="476412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000" b="1" dirty="0" smtClean="0"/>
                    <a:t>G3</a:t>
                  </a:r>
                  <a:endParaRPr kumimoji="1" lang="ja-JP" altLang="en-US" sz="2000" b="1" dirty="0"/>
                </a:p>
              </p:txBody>
            </p:sp>
            <p:sp>
              <p:nvSpPr>
                <p:cNvPr id="77" name="テキスト ボックス 76"/>
                <p:cNvSpPr txBox="1"/>
                <p:nvPr/>
              </p:nvSpPr>
              <p:spPr>
                <a:xfrm>
                  <a:off x="5821418" y="-930075"/>
                  <a:ext cx="1416157" cy="70788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en-US" sz="2000" dirty="0" smtClean="0"/>
                    <a:t>Generation </a:t>
                  </a:r>
                </a:p>
                <a:p>
                  <a:pPr algn="ctr"/>
                  <a:r>
                    <a:rPr lang="en-US" altLang="en-US" sz="2000" dirty="0" smtClean="0"/>
                    <a:t>of PDX</a:t>
                  </a:r>
                  <a:endParaRPr kumimoji="1" lang="ja-JP" altLang="en-US" sz="2000" dirty="0"/>
                </a:p>
              </p:txBody>
            </p:sp>
            <p:sp>
              <p:nvSpPr>
                <p:cNvPr id="78" name="下矢印 77"/>
                <p:cNvSpPr/>
                <p:nvPr/>
              </p:nvSpPr>
              <p:spPr>
                <a:xfrm rot="19113012">
                  <a:off x="9903374" y="-618007"/>
                  <a:ext cx="156505" cy="424623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79" name="下矢印 78"/>
                <p:cNvSpPr/>
                <p:nvPr/>
              </p:nvSpPr>
              <p:spPr>
                <a:xfrm rot="2486988" flipH="1">
                  <a:off x="9071065" y="-635577"/>
                  <a:ext cx="169457" cy="459765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80" name="下矢印 79"/>
                <p:cNvSpPr/>
                <p:nvPr/>
              </p:nvSpPr>
              <p:spPr>
                <a:xfrm rot="2486988" flipH="1">
                  <a:off x="8543456" y="719060"/>
                  <a:ext cx="169457" cy="459765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81" name="下矢印 80"/>
                <p:cNvSpPr/>
                <p:nvPr/>
              </p:nvSpPr>
              <p:spPr>
                <a:xfrm rot="2486988" flipH="1">
                  <a:off x="7755878" y="2203557"/>
                  <a:ext cx="169457" cy="459765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82" name="下矢印 81"/>
                <p:cNvSpPr/>
                <p:nvPr/>
              </p:nvSpPr>
              <p:spPr>
                <a:xfrm rot="19113012">
                  <a:off x="9225648" y="736631"/>
                  <a:ext cx="156505" cy="424623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83" name="下矢印 82"/>
                <p:cNvSpPr/>
                <p:nvPr/>
              </p:nvSpPr>
              <p:spPr>
                <a:xfrm rot="19113012">
                  <a:off x="8548149" y="2221127"/>
                  <a:ext cx="156505" cy="424623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pic>
              <p:nvPicPr>
                <p:cNvPr id="84" name="図 83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242684" y="-169892"/>
                  <a:ext cx="1075718" cy="847128"/>
                </a:xfrm>
                <a:prstGeom prst="rect">
                  <a:avLst/>
                </a:prstGeom>
              </p:spPr>
            </p:pic>
            <p:sp>
              <p:nvSpPr>
                <p:cNvPr id="85" name="テキスト ボックス 84"/>
                <p:cNvSpPr txBox="1"/>
                <p:nvPr/>
              </p:nvSpPr>
              <p:spPr>
                <a:xfrm>
                  <a:off x="10058600" y="-1582999"/>
                  <a:ext cx="1696293" cy="7078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2000" dirty="0" smtClean="0"/>
                    <a:t>Tumor tissues from patients</a:t>
                  </a:r>
                  <a:endParaRPr kumimoji="1" lang="ja-JP" altLang="en-US" sz="2000" dirty="0"/>
                </a:p>
              </p:txBody>
            </p:sp>
            <p:sp>
              <p:nvSpPr>
                <p:cNvPr id="86" name="Cloud 160"/>
                <p:cNvSpPr/>
                <p:nvPr/>
              </p:nvSpPr>
              <p:spPr>
                <a:xfrm>
                  <a:off x="8782379" y="-58025"/>
                  <a:ext cx="315465" cy="242101"/>
                </a:xfrm>
                <a:prstGeom prst="cloud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kern="1200"/>
                </a:p>
              </p:txBody>
            </p:sp>
            <p:pic>
              <p:nvPicPr>
                <p:cNvPr id="87" name="図 86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868060" y="-169892"/>
                  <a:ext cx="1075718" cy="847128"/>
                </a:xfrm>
                <a:prstGeom prst="rect">
                  <a:avLst/>
                </a:prstGeom>
              </p:spPr>
            </p:pic>
            <p:sp>
              <p:nvSpPr>
                <p:cNvPr id="88" name="Cloud 160"/>
                <p:cNvSpPr/>
                <p:nvPr/>
              </p:nvSpPr>
              <p:spPr>
                <a:xfrm>
                  <a:off x="10407755" y="-58025"/>
                  <a:ext cx="315465" cy="242101"/>
                </a:xfrm>
                <a:prstGeom prst="cloud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kern="1200"/>
                </a:p>
              </p:txBody>
            </p:sp>
            <p:pic>
              <p:nvPicPr>
                <p:cNvPr id="89" name="図 88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736422" y="1258291"/>
                  <a:ext cx="1075718" cy="847128"/>
                </a:xfrm>
                <a:prstGeom prst="rect">
                  <a:avLst/>
                </a:prstGeom>
              </p:spPr>
            </p:pic>
            <p:sp>
              <p:nvSpPr>
                <p:cNvPr id="90" name="Cloud 160"/>
                <p:cNvSpPr/>
                <p:nvPr/>
              </p:nvSpPr>
              <p:spPr>
                <a:xfrm>
                  <a:off x="8276117" y="1370158"/>
                  <a:ext cx="315465" cy="242101"/>
                </a:xfrm>
                <a:prstGeom prst="cloud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kern="1200"/>
                </a:p>
              </p:txBody>
            </p:sp>
            <p:pic>
              <p:nvPicPr>
                <p:cNvPr id="91" name="図 90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152593" y="1258605"/>
                  <a:ext cx="1075718" cy="847128"/>
                </a:xfrm>
                <a:prstGeom prst="rect">
                  <a:avLst/>
                </a:prstGeom>
              </p:spPr>
            </p:pic>
            <p:sp>
              <p:nvSpPr>
                <p:cNvPr id="92" name="Cloud 160"/>
                <p:cNvSpPr/>
                <p:nvPr/>
              </p:nvSpPr>
              <p:spPr>
                <a:xfrm>
                  <a:off x="9692288" y="1370472"/>
                  <a:ext cx="315465" cy="242101"/>
                </a:xfrm>
                <a:prstGeom prst="cloud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kern="1200"/>
                </a:p>
              </p:txBody>
            </p:sp>
            <p:pic>
              <p:nvPicPr>
                <p:cNvPr id="93" name="図 92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064150" y="2745792"/>
                  <a:ext cx="1075718" cy="847128"/>
                </a:xfrm>
                <a:prstGeom prst="rect">
                  <a:avLst/>
                </a:prstGeom>
              </p:spPr>
            </p:pic>
            <p:sp>
              <p:nvSpPr>
                <p:cNvPr id="94" name="Cloud 160"/>
                <p:cNvSpPr/>
                <p:nvPr/>
              </p:nvSpPr>
              <p:spPr>
                <a:xfrm>
                  <a:off x="7603845" y="2857659"/>
                  <a:ext cx="315465" cy="242101"/>
                </a:xfrm>
                <a:prstGeom prst="cloud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kern="1200"/>
                </a:p>
              </p:txBody>
            </p:sp>
            <p:pic>
              <p:nvPicPr>
                <p:cNvPr id="95" name="図 94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444212" y="2747473"/>
                  <a:ext cx="1075718" cy="847128"/>
                </a:xfrm>
                <a:prstGeom prst="rect">
                  <a:avLst/>
                </a:prstGeom>
              </p:spPr>
            </p:pic>
            <p:sp>
              <p:nvSpPr>
                <p:cNvPr id="96" name="Cloud 160"/>
                <p:cNvSpPr/>
                <p:nvPr/>
              </p:nvSpPr>
              <p:spPr>
                <a:xfrm>
                  <a:off x="8983907" y="2859340"/>
                  <a:ext cx="315465" cy="242101"/>
                </a:xfrm>
                <a:prstGeom prst="cloud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kern="1200"/>
                </a:p>
              </p:txBody>
            </p:sp>
            <p:grpSp>
              <p:nvGrpSpPr>
                <p:cNvPr id="97" name="グループ化 96"/>
                <p:cNvGrpSpPr/>
                <p:nvPr/>
              </p:nvGrpSpPr>
              <p:grpSpPr>
                <a:xfrm>
                  <a:off x="9062753" y="-1758438"/>
                  <a:ext cx="945000" cy="1160354"/>
                  <a:chOff x="3828287" y="2776681"/>
                  <a:chExt cx="945000" cy="1160354"/>
                </a:xfrm>
              </p:grpSpPr>
              <p:sp>
                <p:nvSpPr>
                  <p:cNvPr id="98" name="Cloud 160"/>
                  <p:cNvSpPr/>
                  <p:nvPr/>
                </p:nvSpPr>
                <p:spPr>
                  <a:xfrm>
                    <a:off x="4440285" y="3178283"/>
                    <a:ext cx="333002" cy="255560"/>
                  </a:xfrm>
                  <a:prstGeom prst="cloud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lvl1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kern="1200"/>
                  </a:p>
                </p:txBody>
              </p:sp>
              <p:pic>
                <p:nvPicPr>
                  <p:cNvPr id="99" name="図 98"/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3828287" y="2776681"/>
                    <a:ext cx="583007" cy="1160354"/>
                  </a:xfrm>
                  <a:prstGeom prst="rect">
                    <a:avLst/>
                  </a:prstGeom>
                </p:spPr>
              </p:pic>
            </p:grpSp>
          </p:grpSp>
          <p:grpSp>
            <p:nvGrpSpPr>
              <p:cNvPr id="62" name="グループ化 61"/>
              <p:cNvGrpSpPr/>
              <p:nvPr/>
            </p:nvGrpSpPr>
            <p:grpSpPr>
              <a:xfrm>
                <a:off x="494785" y="-985674"/>
                <a:ext cx="5271796" cy="4285489"/>
                <a:chOff x="853215" y="2776681"/>
                <a:chExt cx="4340813" cy="3528685"/>
              </a:xfrm>
            </p:grpSpPr>
            <p:sp>
              <p:nvSpPr>
                <p:cNvPr id="63" name="テキスト ボックス 62"/>
                <p:cNvSpPr txBox="1"/>
                <p:nvPr/>
              </p:nvSpPr>
              <p:spPr>
                <a:xfrm>
                  <a:off x="853215" y="3920485"/>
                  <a:ext cx="2352458" cy="7078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2000" dirty="0"/>
                    <a:t>NSG</a:t>
                  </a:r>
                  <a:r>
                    <a:rPr lang="ja-JP" altLang="en-US" sz="2000" dirty="0"/>
                    <a:t> </a:t>
                  </a:r>
                  <a:r>
                    <a:rPr lang="en-US" altLang="ja-JP" sz="2000" dirty="0"/>
                    <a:t>mice</a:t>
                  </a:r>
                </a:p>
                <a:p>
                  <a:pPr algn="ctr"/>
                  <a:r>
                    <a:rPr lang="en-US" altLang="ja-JP" sz="2000" dirty="0"/>
                    <a:t>(6 -12</a:t>
                  </a:r>
                  <a:r>
                    <a:rPr lang="ja-JP" altLang="en-US" sz="2000" dirty="0"/>
                    <a:t> </a:t>
                  </a:r>
                  <a:r>
                    <a:rPr lang="en-US" altLang="ja-JP" sz="2000" dirty="0"/>
                    <a:t>weeks of </a:t>
                  </a:r>
                  <a:r>
                    <a:rPr lang="en-US" altLang="ja-JP" sz="2000" dirty="0" smtClean="0"/>
                    <a:t>age)</a:t>
                  </a:r>
                </a:p>
              </p:txBody>
            </p:sp>
            <p:sp>
              <p:nvSpPr>
                <p:cNvPr id="64" name="テキスト ボックス 63"/>
                <p:cNvSpPr txBox="1"/>
                <p:nvPr/>
              </p:nvSpPr>
              <p:spPr>
                <a:xfrm>
                  <a:off x="3178270" y="3921353"/>
                  <a:ext cx="2015758" cy="7078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2000" dirty="0"/>
                    <a:t>Tumor tissues</a:t>
                  </a:r>
                </a:p>
                <a:p>
                  <a:pPr algn="ctr"/>
                  <a:r>
                    <a:rPr lang="en-US" altLang="ja-JP" sz="2000" dirty="0"/>
                    <a:t>from patients</a:t>
                  </a:r>
                  <a:endParaRPr lang="ja-JP" altLang="en-US" sz="2000" dirty="0"/>
                </a:p>
              </p:txBody>
            </p:sp>
            <p:sp>
              <p:nvSpPr>
                <p:cNvPr id="65" name="下矢印 64"/>
                <p:cNvSpPr/>
                <p:nvPr/>
              </p:nvSpPr>
              <p:spPr>
                <a:xfrm rot="19113012">
                  <a:off x="2490228" y="4581767"/>
                  <a:ext cx="219801" cy="596353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66" name="下矢印 65"/>
                <p:cNvSpPr/>
                <p:nvPr/>
              </p:nvSpPr>
              <p:spPr>
                <a:xfrm rot="2486988" flipH="1">
                  <a:off x="3765733" y="4565921"/>
                  <a:ext cx="219801" cy="596353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67" name="テキスト ボックス 66"/>
                <p:cNvSpPr txBox="1"/>
                <p:nvPr/>
              </p:nvSpPr>
              <p:spPr>
                <a:xfrm>
                  <a:off x="1948826" y="5975914"/>
                  <a:ext cx="2656842" cy="3294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2000" dirty="0"/>
                    <a:t>Subcutaneous implantation</a:t>
                  </a:r>
                  <a:endParaRPr lang="ja-JP" altLang="en-US" sz="2000" dirty="0"/>
                </a:p>
              </p:txBody>
            </p:sp>
            <p:pic>
              <p:nvPicPr>
                <p:cNvPr id="68" name="図 67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49246" y="3006673"/>
                  <a:ext cx="1160396" cy="913812"/>
                </a:xfrm>
                <a:prstGeom prst="rect">
                  <a:avLst/>
                </a:prstGeom>
              </p:spPr>
            </p:pic>
            <p:pic>
              <p:nvPicPr>
                <p:cNvPr id="69" name="図 68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97049" y="5098268"/>
                  <a:ext cx="1160396" cy="913812"/>
                </a:xfrm>
                <a:prstGeom prst="rect">
                  <a:avLst/>
                </a:prstGeom>
              </p:spPr>
            </p:pic>
            <p:sp>
              <p:nvSpPr>
                <p:cNvPr id="70" name="Cloud 160"/>
                <p:cNvSpPr/>
                <p:nvPr/>
              </p:nvSpPr>
              <p:spPr>
                <a:xfrm>
                  <a:off x="3278987" y="5239440"/>
                  <a:ext cx="333002" cy="255560"/>
                </a:xfrm>
                <a:prstGeom prst="cloud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>
                  <a:lvl1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>
                    <a:defRPr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endParaRPr lang="en-US" kern="1200"/>
                </a:p>
              </p:txBody>
            </p:sp>
            <p:grpSp>
              <p:nvGrpSpPr>
                <p:cNvPr id="71" name="グループ化 70"/>
                <p:cNvGrpSpPr/>
                <p:nvPr/>
              </p:nvGrpSpPr>
              <p:grpSpPr>
                <a:xfrm>
                  <a:off x="3828287" y="2776681"/>
                  <a:ext cx="945000" cy="1160354"/>
                  <a:chOff x="3828287" y="2776681"/>
                  <a:chExt cx="945000" cy="1160354"/>
                </a:xfrm>
              </p:grpSpPr>
              <p:sp>
                <p:nvSpPr>
                  <p:cNvPr id="72" name="Cloud 160"/>
                  <p:cNvSpPr/>
                  <p:nvPr/>
                </p:nvSpPr>
                <p:spPr>
                  <a:xfrm>
                    <a:off x="4440285" y="3178283"/>
                    <a:ext cx="333002" cy="255560"/>
                  </a:xfrm>
                  <a:prstGeom prst="cloud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>
                    <a:lvl1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>
                      <a:defRPr>
                        <a:solidFill>
                          <a:schemeClr val="lt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kern="1200"/>
                  </a:p>
                </p:txBody>
              </p:sp>
              <p:pic>
                <p:nvPicPr>
                  <p:cNvPr id="73" name="図 72"/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3828287" y="2776681"/>
                    <a:ext cx="583007" cy="1160354"/>
                  </a:xfrm>
                  <a:prstGeom prst="rect">
                    <a:avLst/>
                  </a:prstGeom>
                </p:spPr>
              </p:pic>
            </p:grpSp>
          </p:grpSp>
        </p:grpSp>
        <p:sp>
          <p:nvSpPr>
            <p:cNvPr id="106" name="テキスト ボックス 105"/>
            <p:cNvSpPr txBox="1"/>
            <p:nvPr/>
          </p:nvSpPr>
          <p:spPr>
            <a:xfrm>
              <a:off x="5521201" y="709570"/>
              <a:ext cx="26844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800" b="1" dirty="0" smtClean="0"/>
                <a:t>b</a:t>
              </a:r>
              <a:endParaRPr lang="ja-JP" altLang="en-US" sz="2800" b="1" dirty="0"/>
            </a:p>
          </p:txBody>
        </p:sp>
        <p:sp>
          <p:nvSpPr>
            <p:cNvPr id="107" name="テキスト ボックス 106"/>
            <p:cNvSpPr txBox="1"/>
            <p:nvPr/>
          </p:nvSpPr>
          <p:spPr>
            <a:xfrm>
              <a:off x="327093" y="6397023"/>
              <a:ext cx="26844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2800" b="1" dirty="0"/>
                <a:t>c</a:t>
              </a:r>
              <a:endParaRPr lang="ja-JP" altLang="en-US" sz="2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8712867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6</TotalTime>
  <Words>167</Words>
  <Application>Microsoft Office PowerPoint</Application>
  <PresentationFormat>ユーザー設定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yotaro Ohkuma</dc:creator>
  <cp:lastModifiedBy>Ohkuma Ryotaro</cp:lastModifiedBy>
  <cp:revision>65</cp:revision>
  <dcterms:created xsi:type="dcterms:W3CDTF">2018-11-02T17:24:25Z</dcterms:created>
  <dcterms:modified xsi:type="dcterms:W3CDTF">2019-05-06T17:15:14Z</dcterms:modified>
</cp:coreProperties>
</file>